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510" r:id="rId2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869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73" autoAdjust="0"/>
    <p:restoredTop sz="86331" autoAdjust="0"/>
  </p:normalViewPr>
  <p:slideViewPr>
    <p:cSldViewPr snapToGrid="0">
      <p:cViewPr varScale="1">
        <p:scale>
          <a:sx n="70" d="100"/>
          <a:sy n="70" d="100"/>
        </p:scale>
        <p:origin x="2310" y="84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8B7A6-A418-4C37-8DE7-370EEF89986F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F0C8CD-7C34-44D0-AB1A-3784C53859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2208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36F8749-30D0-7E33-91CF-DA173360265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69F85C68-7ED3-235B-D81F-0B95F5B5F8A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4980C3DB-3073-6DD7-5526-2F9DAD5514D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 defTabSz="914400">
              <a:defRPr/>
            </a:pPr>
            <a:r>
              <a:rPr lang="en-US" sz="1200" b="1" kern="10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Fig. S4</a:t>
            </a:r>
            <a:r>
              <a:rPr lang="en-US" sz="1200" b="1" kern="100">
                <a:solidFill>
                  <a:srgbClr val="FF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</a:rPr>
              <a:t>: 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</a:rPr>
              <a:t>Effects of </a:t>
            </a:r>
            <a:r>
              <a:rPr lang="en-US" sz="1200" b="1" i="1" kern="100">
                <a:latin typeface="Arial" panose="020B0604020202020204" pitchFamily="34" charset="0"/>
                <a:ea typeface="Aptos" panose="020B0004020202020204" pitchFamily="34" charset="0"/>
              </a:rPr>
              <a:t>Pseudomonas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</a:rPr>
              <a:t> </a:t>
            </a:r>
            <a:r>
              <a:rPr lang="en-US" sz="1200" b="1" i="1" kern="100">
                <a:latin typeface="Arial" panose="020B0604020202020204" pitchFamily="34" charset="0"/>
                <a:ea typeface="Aptos" panose="020B0004020202020204" pitchFamily="34" charset="0"/>
              </a:rPr>
              <a:t>aeruginosa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</a:rPr>
              <a:t> treatment on antigen presentation, LRRK2, and pRab10 in plated PBMCs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</a:rPr>
              <a:t>. Bar graphs overlaid with scatter plots showing levels of HLA-DR, LRRK2, and pRab10 in classical and intermediate monocytes after 24h of treatment with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</a:rPr>
              <a:t>P. aeruginosa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</a:rPr>
              <a:t>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</a:rPr>
              <a:t>A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</a:rPr>
              <a:t>) 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ntigen presentation measured by HLA-DR expression in classical monocytes (CD14+/CD16-) (Treatmen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&lt; 0.001)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Antigen presentation measured by HLA-DR expression in intermediate monocytes (CD14+/CD16+) (Treatmen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0675). </a:t>
            </a:r>
            <a:r>
              <a:rPr lang="en-US" sz="12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</a:t>
            </a:r>
            <a:r>
              <a:rPr lang="en-US" sz="12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12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Rab10</a:t>
            </a:r>
            <a:r>
              <a:rPr lang="en-US" sz="12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levels in classical monocytes (CD14+/CD16-) (Treatment </a:t>
            </a:r>
            <a:r>
              <a:rPr lang="en-US" sz="12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b="0" i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)</a:t>
            </a:r>
            <a:r>
              <a:rPr lang="en-US" sz="12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</a:rPr>
              <a:t>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</a:rPr>
              <a:t>D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</a:rPr>
              <a:t>) 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Rab10 levels in intermediate monocytes (CD14+/CD16+) (Treatmen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1302)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LRRK2 levels in classical monocytes (CD14+/CD16-) (Treatmen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0023)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LRRK2 levels in intermediate monocytes (CD14+/CD16+) (Treatmen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0268). </a:t>
            </a:r>
            <a:r>
              <a:rPr lang="en-US" sz="12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ars represent mean +/- SEM. NHCs, </a:t>
            </a:r>
            <a:r>
              <a:rPr lang="en-US" sz="12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 </a:t>
            </a:r>
            <a:r>
              <a:rPr lang="en-US" sz="12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= 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43</a:t>
            </a:r>
            <a:r>
              <a:rPr lang="en-US" sz="12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; iPD, </a:t>
            </a:r>
            <a:r>
              <a:rPr lang="en-US" sz="12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2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33</a:t>
            </a:r>
            <a:r>
              <a:rPr lang="en-US" sz="12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; </a:t>
            </a:r>
            <a:r>
              <a:rPr lang="en-US" sz="12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LRRK2-</a:t>
            </a:r>
            <a:r>
              <a:rPr lang="en-US" sz="12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D, </a:t>
            </a:r>
            <a:r>
              <a:rPr lang="en-US" sz="12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2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11; </a:t>
            </a:r>
            <a:r>
              <a:rPr lang="en-US" sz="12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BA-</a:t>
            </a:r>
            <a:r>
              <a:rPr lang="en-US" sz="12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D, </a:t>
            </a:r>
            <a:r>
              <a:rPr lang="en-US" sz="12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2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1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5</a:t>
            </a:r>
            <a:r>
              <a:rPr lang="en-US" sz="12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Each symbol represents the measurement from a single individual. The results in A-F were analyzed using 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wo</a:t>
            </a:r>
            <a:r>
              <a:rPr lang="en-US" sz="12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-way ANOVA with Tukey’s corrections for multiple comparisons. Only statistically significant differences are shown (</a:t>
            </a:r>
            <a:r>
              <a:rPr lang="en-US" sz="12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2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&lt; 0.05)</a:t>
            </a:r>
            <a:r>
              <a:rPr lang="en-US" sz="12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r>
              <a:rPr lang="en-US" sz="12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 Samples with less than 100 live cells of the 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relevant cell subtype</a:t>
            </a:r>
            <a:r>
              <a:rPr lang="en-US" sz="12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were excluded. </a:t>
            </a:r>
            <a:endParaRPr lang="en-US" sz="1200" b="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15EDA0-6F69-2A97-65C7-B8C597C3B45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F0C8CD-7C34-44D0-AB1A-3784C538593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4566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878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385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986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11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260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196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14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3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077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9813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174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5944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1D994BE-D397-E42B-8CEC-2BA55F13734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>
            <a:extLst>
              <a:ext uri="{FF2B5EF4-FFF2-40B4-BE49-F238E27FC236}">
                <a16:creationId xmlns:a16="http://schemas.microsoft.com/office/drawing/2014/main" id="{9FEE14FD-F41A-BF0D-B126-659E961ADE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75673" y="386709"/>
            <a:ext cx="3243128" cy="361188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06081161-3664-6577-8F8B-E6D18DF1340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50306" y="3961394"/>
            <a:ext cx="3237911" cy="361188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966EF176-25FA-131E-2F0D-C82F7BA6884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4500" y="3971214"/>
            <a:ext cx="3233673" cy="361188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B80140AD-C379-0CCB-D7A5-02D57FB10E3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60703" y="380359"/>
            <a:ext cx="3225230" cy="361188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165424AB-3FDC-3895-107B-5A2DE98EACD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2157" y="369847"/>
            <a:ext cx="3247378" cy="361188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04B5935-84A2-64F2-61EE-E2C774AE4258}"/>
              </a:ext>
            </a:extLst>
          </p:cNvPr>
          <p:cNvSpPr txBox="1"/>
          <p:nvPr/>
        </p:nvSpPr>
        <p:spPr>
          <a:xfrm>
            <a:off x="0" y="0"/>
            <a:ext cx="82671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Fig</a:t>
            </a:r>
            <a:r>
              <a:rPr lang="en-US" sz="2400" b="1"/>
              <a:t>. S4</a:t>
            </a:r>
            <a:endParaRPr lang="en-US" sz="2400" b="1" dirty="0">
              <a:solidFill>
                <a:srgbClr val="FF0000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0A8B7E8-58BD-FB20-BE38-E1C5F75D2BAD}"/>
              </a:ext>
            </a:extLst>
          </p:cNvPr>
          <p:cNvSpPr txBox="1"/>
          <p:nvPr/>
        </p:nvSpPr>
        <p:spPr>
          <a:xfrm>
            <a:off x="359199" y="7479268"/>
            <a:ext cx="1144830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914400">
              <a:defRPr/>
            </a:pP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Fig</a:t>
            </a:r>
            <a:r>
              <a:rPr lang="en-US" sz="1200" b="1" kern="10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. S4:</a:t>
            </a:r>
            <a:r>
              <a:rPr lang="en-US" sz="1200" b="1" kern="100">
                <a:solidFill>
                  <a:srgbClr val="FF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</a:rPr>
              <a:t> 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</a:rPr>
              <a:t>Effects of </a:t>
            </a:r>
            <a:r>
              <a:rPr lang="en-US" sz="1200" b="1" i="1" kern="100" dirty="0">
                <a:latin typeface="Arial" panose="020B0604020202020204" pitchFamily="34" charset="0"/>
                <a:ea typeface="Aptos" panose="020B0004020202020204" pitchFamily="34" charset="0"/>
              </a:rPr>
              <a:t>Pseudomonas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</a:rPr>
              <a:t> </a:t>
            </a:r>
            <a:r>
              <a:rPr lang="en-US" sz="1200" b="1" i="1" kern="100" dirty="0">
                <a:latin typeface="Arial" panose="020B0604020202020204" pitchFamily="34" charset="0"/>
                <a:ea typeface="Aptos" panose="020B0004020202020204" pitchFamily="34" charset="0"/>
              </a:rPr>
              <a:t>aeruginosa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</a:rPr>
              <a:t> treatment 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</a:rPr>
              <a:t>on antigen presentation, LRRK2, and pRab10 in plated 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</a:rPr>
              <a:t>PBMCs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</a:rPr>
              <a:t>. Bar graphs overlaid with scatter plots showing levels of HLA-DR, LRRK2, and pRab10 in classical and intermediate monocytes after 24h of treatment with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</a:rPr>
              <a:t>P. aeruginosa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</a:rPr>
              <a:t>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</a:rPr>
              <a:t>A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</a:rPr>
              <a:t>)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ntigen presentation measured by HLA-DR expression in classical monocytes (CD14+/CD16-) (Treatmen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&lt; 0.001)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Antigen presentation measured by HLA-DR expression in intermediate monocytes (CD14+/CD16+) (Treatmen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0675). 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Rab10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levels in classical monocytes (CD14+/CD16-) (Treatment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b="0" i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&lt; 0.0001)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</a:rPr>
              <a:t>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</a:rPr>
              <a:t>D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</a:rPr>
              <a:t>)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Rab10 levels in intermediate monocytes (CD14+/CD16+) (Treatmen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1302)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LRRK2 levels in classical monocytes (CD14+/CD16-) (Treatmen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0023)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LRRK2 levels in intermediate monocytes (CD14+/CD16+) (Treatmen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0268). 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ars represent mean +/- SEM. NHCs,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 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=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43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; </a:t>
            </a:r>
            <a:r>
              <a:rPr lang="en-US" sz="1200" b="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PD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33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;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LRRK2-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D,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11;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BA-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D,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1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5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Each symbol represents the measurement from a single individual. The results in A-F were analyzed using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wo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-way ANOVA with Tukey’s corrections for multiple comparisons. Only statistically significant differences are shown (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&lt; 0.05)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 Samples with less than 100 live cells of the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relevant cell subtype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were excluded.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5ACF855-6C93-D034-A6F9-13A620A1BA84}"/>
              </a:ext>
            </a:extLst>
          </p:cNvPr>
          <p:cNvSpPr txBox="1"/>
          <p:nvPr/>
        </p:nvSpPr>
        <p:spPr>
          <a:xfrm>
            <a:off x="366054" y="361308"/>
            <a:ext cx="3432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4EF0D30-FFFD-BB9C-1486-573453A32597}"/>
              </a:ext>
            </a:extLst>
          </p:cNvPr>
          <p:cNvSpPr txBox="1"/>
          <p:nvPr/>
        </p:nvSpPr>
        <p:spPr>
          <a:xfrm>
            <a:off x="3642654" y="361308"/>
            <a:ext cx="3432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57A5C8B-4805-439C-5E09-81B93119C67A}"/>
              </a:ext>
            </a:extLst>
          </p:cNvPr>
          <p:cNvSpPr txBox="1"/>
          <p:nvPr/>
        </p:nvSpPr>
        <p:spPr>
          <a:xfrm>
            <a:off x="6850674" y="361308"/>
            <a:ext cx="3432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2623C1E-F505-0539-9B63-0F3BF4C7787B}"/>
              </a:ext>
            </a:extLst>
          </p:cNvPr>
          <p:cNvSpPr txBox="1"/>
          <p:nvPr/>
        </p:nvSpPr>
        <p:spPr>
          <a:xfrm>
            <a:off x="366054" y="3960489"/>
            <a:ext cx="3432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30DC01C-36BA-FF51-00F6-C09235B9C8E7}"/>
              </a:ext>
            </a:extLst>
          </p:cNvPr>
          <p:cNvSpPr txBox="1"/>
          <p:nvPr/>
        </p:nvSpPr>
        <p:spPr>
          <a:xfrm>
            <a:off x="3642654" y="3960489"/>
            <a:ext cx="3432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5BCF1EF-D1F3-A494-1BC0-134EE5BF3C1F}"/>
              </a:ext>
            </a:extLst>
          </p:cNvPr>
          <p:cNvSpPr txBox="1"/>
          <p:nvPr/>
        </p:nvSpPr>
        <p:spPr>
          <a:xfrm>
            <a:off x="6850674" y="3960489"/>
            <a:ext cx="3432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EE582B47-EB41-A359-93AC-07C5AD2448D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283763" y="1690788"/>
            <a:ext cx="1459382" cy="128016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549A45AD-5C37-FEE9-7604-8347C1D550F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64887" y="3960108"/>
            <a:ext cx="3229446" cy="36118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99901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067</TotalTime>
  <Words>518</Words>
  <Application>Microsoft Office PowerPoint</Application>
  <PresentationFormat>Custom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RRK2/GBA1 mutations peripheral immune cells in Parkinson’s disease</dc:title>
  <dc:creator>Julian Mark</dc:creator>
  <cp:lastModifiedBy>Mark, Julian</cp:lastModifiedBy>
  <cp:revision>864</cp:revision>
  <dcterms:created xsi:type="dcterms:W3CDTF">2025-01-19T15:31:25Z</dcterms:created>
  <dcterms:modified xsi:type="dcterms:W3CDTF">2025-10-25T20:12:58Z</dcterms:modified>
</cp:coreProperties>
</file>